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7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MGMT</a:t>
            </a:r>
            <a:r>
              <a:rPr lang="en-GB" sz="1600" dirty="0" smtClean="0"/>
              <a:t> gene. A) Wild (Template </a:t>
            </a:r>
            <a:r>
              <a:rPr lang="en-US" sz="1600" dirty="0"/>
              <a:t>1eh6_A</a:t>
            </a:r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/>
              <a:t>1eh6_A</a:t>
            </a:r>
            <a:r>
              <a:rPr lang="en-US" sz="1600" dirty="0" smtClean="0"/>
              <a:t>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85786" y="142852"/>
            <a:ext cx="2985475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142852"/>
            <a:ext cx="3571900" cy="300039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85786" y="3038942"/>
            <a:ext cx="3000396" cy="281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14686"/>
            <a:ext cx="3571900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1</cp:revision>
  <dcterms:created xsi:type="dcterms:W3CDTF">2018-05-10T07:33:24Z</dcterms:created>
  <dcterms:modified xsi:type="dcterms:W3CDTF">2018-05-29T07:29:34Z</dcterms:modified>
</cp:coreProperties>
</file>